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10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57" userDrawn="1">
          <p15:clr>
            <a:srgbClr val="A4A3A4"/>
          </p15:clr>
        </p15:guide>
        <p15:guide id="2" pos="4241" userDrawn="1">
          <p15:clr>
            <a:srgbClr val="A4A3A4"/>
          </p15:clr>
        </p15:guide>
        <p15:guide id="3" pos="25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34"/>
    <p:restoredTop sz="94668"/>
  </p:normalViewPr>
  <p:slideViewPr>
    <p:cSldViewPr snapToGrid="0" snapToObjects="1" showGuides="1">
      <p:cViewPr varScale="1">
        <p:scale>
          <a:sx n="136" d="100"/>
          <a:sy n="136" d="100"/>
        </p:scale>
        <p:origin x="1352" y="184"/>
      </p:cViewPr>
      <p:guideLst>
        <p:guide orient="horz" pos="1057"/>
        <p:guide pos="4241"/>
        <p:guide pos="25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/Users/silviozaina/Documents/PROJECTS_MEX_MYOWN/PRE-POSTPRANDIAL%20BLOOD/PS_FS_2018_850K/AZUCENA's_analysis_2020/Comps_Cellular_Sorted/Alldata_PromCGIdistribu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old enrich'!$AC$2</c:f>
              <c:strCache>
                <c:ptCount val="1"/>
                <c:pt idx="0">
                  <c:v>F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ysClr val="windowText" lastClr="0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C$3:$AC$8</c:f>
              <c:numCache>
                <c:formatCode>General</c:formatCode>
                <c:ptCount val="6"/>
                <c:pt idx="0">
                  <c:v>-0.40053792958372875</c:v>
                </c:pt>
                <c:pt idx="1">
                  <c:v>-0.18057224564182092</c:v>
                </c:pt>
                <c:pt idx="2">
                  <c:v>-0.70626879694329003</c:v>
                </c:pt>
                <c:pt idx="3">
                  <c:v>-1.9159578283454982E-2</c:v>
                </c:pt>
                <c:pt idx="4">
                  <c:v>0.16349873228287928</c:v>
                </c:pt>
                <c:pt idx="5">
                  <c:v>0.32805419768420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093-6647-A87F-1F22309355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old enrich'!$AM$9</c:f>
              <c:strCache>
                <c:ptCount val="1"/>
                <c:pt idx="0">
                  <c:v>Ow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M$10:$AM$13</c:f>
              <c:numCache>
                <c:formatCode>General</c:formatCode>
                <c:ptCount val="4"/>
                <c:pt idx="0">
                  <c:v>1.1403212883974145</c:v>
                </c:pt>
                <c:pt idx="1">
                  <c:v>-0.26144114775812666</c:v>
                </c:pt>
                <c:pt idx="2">
                  <c:v>0.27651763519741585</c:v>
                </c:pt>
                <c:pt idx="3">
                  <c:v>-0.670901946949746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111-6242-869A-D30CA54824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old enrich'!$AD$2</c:f>
              <c:strCache>
                <c:ptCount val="1"/>
                <c:pt idx="0">
                  <c:v>P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D$3:$AD$8</c:f>
              <c:numCache>
                <c:formatCode>General</c:formatCode>
                <c:ptCount val="6"/>
                <c:pt idx="0">
                  <c:v>-0.20309186537751181</c:v>
                </c:pt>
                <c:pt idx="1">
                  <c:v>-0.79468109202249348</c:v>
                </c:pt>
                <c:pt idx="2">
                  <c:v>-1.3692338096657191</c:v>
                </c:pt>
                <c:pt idx="3">
                  <c:v>3.013571797331871E-2</c:v>
                </c:pt>
                <c:pt idx="4">
                  <c:v>-0.47393118833241243</c:v>
                </c:pt>
                <c:pt idx="5">
                  <c:v>0.360294534684412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A0F-214A-BBFB-C5D8FE7015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8145760587339963E-2"/>
          <c:y val="8.2549999999999998E-2"/>
          <c:w val="0.6110580624944042"/>
          <c:h val="0.83489999999999998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ld enrich'!$AE$2</c:f>
              <c:strCache>
                <c:ptCount val="1"/>
                <c:pt idx="0">
                  <c:v>P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E$3:$AE$8</c:f>
              <c:numCache>
                <c:formatCode>General</c:formatCode>
                <c:ptCount val="6"/>
                <c:pt idx="0">
                  <c:v>-0.3814291066360242</c:v>
                </c:pt>
                <c:pt idx="1">
                  <c:v>-1.5025003405291832</c:v>
                </c:pt>
                <c:pt idx="2">
                  <c:v>0.97654102717601088</c:v>
                </c:pt>
                <c:pt idx="3">
                  <c:v>0.1618664163921075</c:v>
                </c:pt>
                <c:pt idx="4">
                  <c:v>-3</c:v>
                </c:pt>
                <c:pt idx="5">
                  <c:v>0.239827014672468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264-C142-927E-1FEBBB172DD5}"/>
            </c:ext>
          </c:extLst>
        </c:ser>
        <c:ser>
          <c:idx val="1"/>
          <c:order val="1"/>
          <c:tx>
            <c:strRef>
              <c:f>'Fold enrich'!$AG$2</c:f>
              <c:strCache>
                <c:ptCount val="1"/>
                <c:pt idx="0">
                  <c:v>C20:1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2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dPt>
            <c:idx val="2"/>
            <c:marker>
              <c:symbol val="circle"/>
              <c:size val="8"/>
              <c:spPr>
                <a:solidFill>
                  <a:schemeClr val="accent2"/>
                </a:solidFill>
                <a:ln w="9525">
                  <a:solidFill>
                    <a:sysClr val="windowText" lastClr="000000"/>
                  </a:solidFill>
                </a:ln>
                <a:effectLst/>
              </c:spPr>
            </c:marker>
            <c:bubble3D val="0"/>
            <c:spPr>
              <a:ln w="1905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A264-C142-927E-1FEBBB172DD5}"/>
              </c:ext>
            </c:extLst>
          </c:dPt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G$3:$AG$8</c:f>
              <c:numCache>
                <c:formatCode>General</c:formatCode>
                <c:ptCount val="6"/>
                <c:pt idx="0">
                  <c:v>-0.6069888070511551</c:v>
                </c:pt>
                <c:pt idx="1">
                  <c:v>-0.19993757050875194</c:v>
                </c:pt>
                <c:pt idx="2">
                  <c:v>-0.70626879694329003</c:v>
                </c:pt>
                <c:pt idx="3">
                  <c:v>0.16865558205474665</c:v>
                </c:pt>
                <c:pt idx="4">
                  <c:v>1.1375035237499351</c:v>
                </c:pt>
                <c:pt idx="5">
                  <c:v>6.990201323015647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264-C142-927E-1FEBBB172DD5}"/>
            </c:ext>
          </c:extLst>
        </c:ser>
        <c:ser>
          <c:idx val="2"/>
          <c:order val="2"/>
          <c:tx>
            <c:strRef>
              <c:f>'Fold enrich'!$AI$2</c:f>
              <c:strCache>
                <c:ptCount val="1"/>
                <c:pt idx="0">
                  <c:v>ED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3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I$3:$AI$8</c:f>
              <c:numCache>
                <c:formatCode>General</c:formatCode>
                <c:ptCount val="6"/>
                <c:pt idx="0">
                  <c:v>-1.203091865377512</c:v>
                </c:pt>
                <c:pt idx="1">
                  <c:v>-0.70895121799660954</c:v>
                </c:pt>
                <c:pt idx="2">
                  <c:v>-0.86673346913653593</c:v>
                </c:pt>
                <c:pt idx="3">
                  <c:v>0.24130088388651241</c:v>
                </c:pt>
                <c:pt idx="4">
                  <c:v>1.0565835283663676</c:v>
                </c:pt>
                <c:pt idx="5">
                  <c:v>0.29090119926673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264-C142-927E-1FEBBB172DD5}"/>
            </c:ext>
          </c:extLst>
        </c:ser>
        <c:ser>
          <c:idx val="3"/>
          <c:order val="3"/>
          <c:tx>
            <c:strRef>
              <c:f>'Fold enrich'!$AK$2</c:f>
              <c:strCache>
                <c:ptCount val="1"/>
                <c:pt idx="0">
                  <c:v>DGL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4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K$3:$AK$8</c:f>
              <c:numCache>
                <c:formatCode>General</c:formatCode>
                <c:ptCount val="6"/>
                <c:pt idx="0">
                  <c:v>1.4499569695115171E-2</c:v>
                </c:pt>
                <c:pt idx="1">
                  <c:v>-0.34330174567992938</c:v>
                </c:pt>
                <c:pt idx="2">
                  <c:v>-3</c:v>
                </c:pt>
                <c:pt idx="3">
                  <c:v>-0.18667567109982966</c:v>
                </c:pt>
                <c:pt idx="4">
                  <c:v>1.4222330006830479</c:v>
                </c:pt>
                <c:pt idx="5">
                  <c:v>0.239827014672468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264-C142-927E-1FEBBB172D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727862834631567"/>
          <c:y val="0.26892888888888888"/>
          <c:w val="0.25891261527442028"/>
          <c:h val="0.476253333333333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MX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8145760587339963E-2"/>
          <c:y val="8.2549999999999998E-2"/>
          <c:w val="0.6110580624944042"/>
          <c:h val="0.83489999999999998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ld enrich'!$AF$2</c:f>
              <c:strCache>
                <c:ptCount val="1"/>
                <c:pt idx="0">
                  <c:v>P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F$3:$AF$8</c:f>
              <c:numCache>
                <c:formatCode>General</c:formatCode>
                <c:ptCount val="6"/>
                <c:pt idx="0">
                  <c:v>0.34218693387116245</c:v>
                </c:pt>
                <c:pt idx="1">
                  <c:v>1.1451979155399357</c:v>
                </c:pt>
                <c:pt idx="2">
                  <c:v>1</c:v>
                </c:pt>
                <c:pt idx="3">
                  <c:v>-0.60026975350900469</c:v>
                </c:pt>
                <c:pt idx="4">
                  <c:v>1.3103401206121505</c:v>
                </c:pt>
                <c:pt idx="5">
                  <c:v>-0.592656892511156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929-BF4A-9048-1F2ECA9312C5}"/>
            </c:ext>
          </c:extLst>
        </c:ser>
        <c:ser>
          <c:idx val="1"/>
          <c:order val="1"/>
          <c:tx>
            <c:strRef>
              <c:f>'Fold enrich'!$AH$2</c:f>
              <c:strCache>
                <c:ptCount val="1"/>
                <c:pt idx="0">
                  <c:v>C20:1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2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dPt>
            <c:idx val="2"/>
            <c:marker>
              <c:symbol val="circle"/>
              <c:size val="8"/>
              <c:spPr>
                <a:solidFill>
                  <a:schemeClr val="accent2"/>
                </a:solidFill>
                <a:ln w="9525">
                  <a:solidFill>
                    <a:sysClr val="windowText" lastClr="000000"/>
                  </a:solidFill>
                </a:ln>
                <a:effectLst/>
              </c:spPr>
            </c:marker>
            <c:bubble3D val="0"/>
            <c:spPr>
              <a:ln w="1905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8929-BF4A-9048-1F2ECA9312C5}"/>
              </c:ext>
            </c:extLst>
          </c:dPt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H$3:$AH$8</c:f>
              <c:numCache>
                <c:formatCode>General</c:formatCode>
                <c:ptCount val="6"/>
                <c:pt idx="0">
                  <c:v>-5.950101174866184E-2</c:v>
                </c:pt>
                <c:pt idx="1">
                  <c:v>-0.82442843541654565</c:v>
                </c:pt>
                <c:pt idx="2">
                  <c:v>1.6156592979440725</c:v>
                </c:pt>
                <c:pt idx="3">
                  <c:v>0.59129289719175115</c:v>
                </c:pt>
                <c:pt idx="4">
                  <c:v>0.94110631094643149</c:v>
                </c:pt>
                <c:pt idx="5">
                  <c:v>-2.55458885167763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929-BF4A-9048-1F2ECA9312C5}"/>
            </c:ext>
          </c:extLst>
        </c:ser>
        <c:ser>
          <c:idx val="2"/>
          <c:order val="2"/>
          <c:tx>
            <c:strRef>
              <c:f>'Fold enrich'!$AJ$2</c:f>
              <c:strCache>
                <c:ptCount val="1"/>
                <c:pt idx="0">
                  <c:v>ED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3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J$3:$AJ$8</c:f>
              <c:numCache>
                <c:formatCode>General</c:formatCode>
                <c:ptCount val="6"/>
                <c:pt idx="0">
                  <c:v>0.16505924627049623</c:v>
                </c:pt>
                <c:pt idx="1">
                  <c:v>-0.60203601408009766</c:v>
                </c:pt>
                <c:pt idx="2">
                  <c:v>1.8402195559632308</c:v>
                </c:pt>
                <c:pt idx="3">
                  <c:v>-0.18667567109982966</c:v>
                </c:pt>
                <c:pt idx="4">
                  <c:v>1.1634987322828794</c:v>
                </c:pt>
                <c:pt idx="5">
                  <c:v>-0.345135486048687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8929-BF4A-9048-1F2ECA9312C5}"/>
            </c:ext>
          </c:extLst>
        </c:ser>
        <c:ser>
          <c:idx val="3"/>
          <c:order val="3"/>
          <c:tx>
            <c:strRef>
              <c:f>'Fold enrich'!$AL$2</c:f>
              <c:strCache>
                <c:ptCount val="1"/>
                <c:pt idx="0">
                  <c:v>DGL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4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L$3:$AL$8</c:f>
              <c:numCache>
                <c:formatCode>General</c:formatCode>
                <c:ptCount val="6"/>
                <c:pt idx="0">
                  <c:v>0.48958445264389772</c:v>
                </c:pt>
                <c:pt idx="1">
                  <c:v>0.38502493021240425</c:v>
                </c:pt>
                <c:pt idx="2">
                  <c:v>1.8402195559632308</c:v>
                </c:pt>
                <c:pt idx="3">
                  <c:v>-0.18667567109982966</c:v>
                </c:pt>
                <c:pt idx="4">
                  <c:v>1.1634987322828794</c:v>
                </c:pt>
                <c:pt idx="5">
                  <c:v>-1.34513548604868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929-BF4A-9048-1F2ECA9312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297206553854414"/>
          <c:y val="0.26892888888888888"/>
          <c:w val="0.26037648849494138"/>
          <c:h val="0.476253333333333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MX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old enrich'!$AC$9</c:f>
              <c:strCache>
                <c:ptCount val="1"/>
                <c:pt idx="0">
                  <c:v>F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C$10:$AC$13</c:f>
              <c:numCache>
                <c:formatCode>General</c:formatCode>
                <c:ptCount val="4"/>
                <c:pt idx="0">
                  <c:v>-0.31034012061215061</c:v>
                </c:pt>
                <c:pt idx="1">
                  <c:v>0.18665464010001301</c:v>
                </c:pt>
                <c:pt idx="2">
                  <c:v>-0.12737930647622756</c:v>
                </c:pt>
                <c:pt idx="3">
                  <c:v>4.299321776831044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ACF-7848-8368-5405091678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ysClr val="windowText" lastClr="000000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old enrich'!$AD$9</c:f>
              <c:strCache>
                <c:ptCount val="1"/>
                <c:pt idx="0">
                  <c:v>PS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D$10:$AD$13</c:f>
              <c:numCache>
                <c:formatCode>General</c:formatCode>
                <c:ptCount val="4"/>
                <c:pt idx="0">
                  <c:v>-0.33948646627166729</c:v>
                </c:pt>
                <c:pt idx="1">
                  <c:v>0.28805667230822607</c:v>
                </c:pt>
                <c:pt idx="2">
                  <c:v>-0.21900978194179585</c:v>
                </c:pt>
                <c:pt idx="3">
                  <c:v>2.292061514191669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06F-DF40-B3B2-B1C591FCE3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8145760587339963E-2"/>
          <c:y val="8.2549999999999998E-2"/>
          <c:w val="0.52908899632912521"/>
          <c:h val="0.83489999999999998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ld enrich'!$AE$9</c:f>
              <c:strCache>
                <c:ptCount val="1"/>
                <c:pt idx="0">
                  <c:v>FS P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E$10:$AE$13</c:f>
              <c:numCache>
                <c:formatCode>General</c:formatCode>
                <c:ptCount val="4"/>
                <c:pt idx="0">
                  <c:v>-1.0313641709093353</c:v>
                </c:pt>
                <c:pt idx="1">
                  <c:v>0.22807456747999372</c:v>
                </c:pt>
                <c:pt idx="2">
                  <c:v>-0.21900978194179585</c:v>
                </c:pt>
                <c:pt idx="3">
                  <c:v>0.178456635063429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425-174A-A333-D9536CE48F39}"/>
            </c:ext>
          </c:extLst>
        </c:ser>
        <c:ser>
          <c:idx val="1"/>
          <c:order val="1"/>
          <c:tx>
            <c:strRef>
              <c:f>'Fold enrich'!$AG$9</c:f>
              <c:strCache>
                <c:ptCount val="1"/>
                <c:pt idx="0">
                  <c:v>FS C20:1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2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dPt>
            <c:idx val="2"/>
            <c:marker>
              <c:symbol val="circle"/>
              <c:size val="8"/>
              <c:spPr>
                <a:solidFill>
                  <a:schemeClr val="accent2"/>
                </a:solidFill>
                <a:ln w="9525">
                  <a:solidFill>
                    <a:sysClr val="windowText" lastClr="000000"/>
                  </a:solidFill>
                </a:ln>
                <a:effectLst/>
              </c:spPr>
            </c:marker>
            <c:bubble3D val="0"/>
            <c:spPr>
              <a:ln w="1905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1425-174A-A333-D9536CE48F39}"/>
              </c:ext>
            </c:extLst>
          </c:dPt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G$10:$AG$13</c:f>
              <c:numCache>
                <c:formatCode>General</c:formatCode>
                <c:ptCount val="4"/>
                <c:pt idx="0">
                  <c:v>0.67029455452091835</c:v>
                </c:pt>
                <c:pt idx="1">
                  <c:v>0.79936213130407341</c:v>
                </c:pt>
                <c:pt idx="2">
                  <c:v>-1.9018196060610966</c:v>
                </c:pt>
                <c:pt idx="3">
                  <c:v>-0.603044859704613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425-174A-A333-D9536CE48F39}"/>
            </c:ext>
          </c:extLst>
        </c:ser>
        <c:ser>
          <c:idx val="2"/>
          <c:order val="2"/>
          <c:tx>
            <c:strRef>
              <c:f>'Fold enrich'!$AI$9</c:f>
              <c:strCache>
                <c:ptCount val="1"/>
                <c:pt idx="0">
                  <c:v>FS ED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3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I$10:$AI$13</c:f>
              <c:numCache>
                <c:formatCode>General</c:formatCode>
                <c:ptCount val="4"/>
                <c:pt idx="0">
                  <c:v>0.5693656456701377</c:v>
                </c:pt>
                <c:pt idx="1">
                  <c:v>0.30750903497439847</c:v>
                </c:pt>
                <c:pt idx="2">
                  <c:v>-3</c:v>
                </c:pt>
                <c:pt idx="3">
                  <c:v>-0.1686420355588391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1425-174A-A333-D9536CE48F39}"/>
            </c:ext>
          </c:extLst>
        </c:ser>
        <c:ser>
          <c:idx val="3"/>
          <c:order val="3"/>
          <c:tx>
            <c:strRef>
              <c:f>'Fold enrich'!$AK$9</c:f>
              <c:strCache>
                <c:ptCount val="1"/>
                <c:pt idx="0">
                  <c:v>FS DGL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4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K$10:$AK$13</c:f>
              <c:numCache>
                <c:formatCode>General</c:formatCode>
                <c:ptCount val="4"/>
                <c:pt idx="0">
                  <c:v>0.5215371205795224</c:v>
                </c:pt>
                <c:pt idx="1">
                  <c:v>0.14401030269151915</c:v>
                </c:pt>
                <c:pt idx="2">
                  <c:v>-3</c:v>
                </c:pt>
                <c:pt idx="3">
                  <c:v>-7.643459746175040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425-174A-A333-D9536CE48F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159324917181482"/>
          <c:y val="0.26187333333333329"/>
          <c:w val="0.25891261527442028"/>
          <c:h val="0.476253333333333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Arial" panose="020B0604020202020204" pitchFamily="34" charset="0"/>
            </a:defRPr>
          </a:pPr>
          <a:endParaRPr lang="en-MX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7.8145760587339963E-2"/>
          <c:y val="8.2549999999999998E-2"/>
          <c:w val="0.53005551078879054"/>
          <c:h val="0.83489999999999998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ld enrich'!$AF$9</c:f>
              <c:strCache>
                <c:ptCount val="1"/>
                <c:pt idx="0">
                  <c:v>PS P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ysClr val="window" lastClr="FFFFFF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F$10:$AF$13</c:f>
              <c:numCache>
                <c:formatCode>General</c:formatCode>
                <c:ptCount val="4"/>
                <c:pt idx="0">
                  <c:v>-0.57337452644594444</c:v>
                </c:pt>
                <c:pt idx="1">
                  <c:v>1.054742964594432</c:v>
                </c:pt>
                <c:pt idx="2">
                  <c:v>-0.19555080911780676</c:v>
                </c:pt>
                <c:pt idx="3">
                  <c:v>-0.3629368507203277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141-BD4C-9918-95A20E6A5F1E}"/>
            </c:ext>
          </c:extLst>
        </c:ser>
        <c:ser>
          <c:idx val="1"/>
          <c:order val="1"/>
          <c:tx>
            <c:strRef>
              <c:f>'Fold enrich'!$AH$9</c:f>
              <c:strCache>
                <c:ptCount val="1"/>
                <c:pt idx="0">
                  <c:v>PS C20:1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2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dPt>
            <c:idx val="2"/>
            <c:marker>
              <c:symbol val="circle"/>
              <c:size val="8"/>
              <c:spPr>
                <a:solidFill>
                  <a:schemeClr val="accent2"/>
                </a:solidFill>
                <a:ln w="9525">
                  <a:solidFill>
                    <a:sysClr val="windowText" lastClr="000000"/>
                  </a:solidFill>
                </a:ln>
                <a:effectLst/>
              </c:spPr>
            </c:marker>
            <c:bubble3D val="0"/>
            <c:spPr>
              <a:ln w="1905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E141-BD4C-9918-95A20E6A5F1E}"/>
              </c:ext>
            </c:extLst>
          </c:dPt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H$10:$AH$13</c:f>
              <c:numCache>
                <c:formatCode>General</c:formatCode>
                <c:ptCount val="4"/>
                <c:pt idx="0">
                  <c:v>-0.37928747432964199</c:v>
                </c:pt>
                <c:pt idx="1">
                  <c:v>0.39497187622473817</c:v>
                </c:pt>
                <c:pt idx="2">
                  <c:v>-0.56478461878352593</c:v>
                </c:pt>
                <c:pt idx="3">
                  <c:v>2.292061514191669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141-BD4C-9918-95A20E6A5F1E}"/>
            </c:ext>
          </c:extLst>
        </c:ser>
        <c:ser>
          <c:idx val="2"/>
          <c:order val="2"/>
          <c:tx>
            <c:strRef>
              <c:f>'Fold enrich'!$AJ$9</c:f>
              <c:strCache>
                <c:ptCount val="1"/>
                <c:pt idx="0">
                  <c:v>PS ED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3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J$10:$AJ$13</c:f>
              <c:numCache>
                <c:formatCode>General</c:formatCode>
                <c:ptCount val="4"/>
                <c:pt idx="0">
                  <c:v>-0.75779909758337194</c:v>
                </c:pt>
                <c:pt idx="1">
                  <c:v>0.61909518564030197</c:v>
                </c:pt>
                <c:pt idx="2">
                  <c:v>-0.34239219744707805</c:v>
                </c:pt>
                <c:pt idx="3">
                  <c:v>-1.54852474974187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141-BD4C-9918-95A20E6A5F1E}"/>
            </c:ext>
          </c:extLst>
        </c:ser>
        <c:ser>
          <c:idx val="3"/>
          <c:order val="3"/>
          <c:tx>
            <c:strRef>
              <c:f>'Fold enrich'!$AL$9</c:f>
              <c:strCache>
                <c:ptCount val="1"/>
                <c:pt idx="0">
                  <c:v>PS DGLA-dmCpG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4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10:$AB$13</c:f>
              <c:numCache>
                <c:formatCode>General</c:formatCode>
                <c:ptCount val="4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</c:numCache>
            </c:numRef>
          </c:xVal>
          <c:yVal>
            <c:numRef>
              <c:f>'Fold enrich'!$AL$10:$AL$13</c:f>
              <c:numCache>
                <c:formatCode>General</c:formatCode>
                <c:ptCount val="4"/>
                <c:pt idx="0">
                  <c:v>-0.15545451863397938</c:v>
                </c:pt>
                <c:pt idx="1">
                  <c:v>1.1037804579029864</c:v>
                </c:pt>
                <c:pt idx="2">
                  <c:v>0.64466874684542408</c:v>
                </c:pt>
                <c:pt idx="3">
                  <c:v>-0.755047953149664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141-BD4C-9918-95A20E6A5F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4297206553854414"/>
          <c:y val="0.26187333333333329"/>
          <c:w val="0.26037648849494138"/>
          <c:h val="0.476253333333333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Arial" panose="020B0604020202020204" pitchFamily="34" charset="0"/>
            </a:defRPr>
          </a:pPr>
          <a:endParaRPr lang="en-MX"/>
        </a:p>
      </c:txPr>
    </c:legend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Fold enrich'!$AM$2</c:f>
              <c:strCache>
                <c:ptCount val="1"/>
                <c:pt idx="0">
                  <c:v>Ow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xVal>
            <c:numRef>
              <c:f>'Fold enrich'!$AB$3:$AB$8</c:f>
              <c:numCache>
                <c:formatCode>General</c:formatCode>
                <c:ptCount val="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</c:numCache>
            </c:numRef>
          </c:xVal>
          <c:yVal>
            <c:numRef>
              <c:f>'Fold enrich'!$AM$3:$AM$8</c:f>
              <c:numCache>
                <c:formatCode>General</c:formatCode>
                <c:ptCount val="6"/>
                <c:pt idx="0">
                  <c:v>0.80527160755711491</c:v>
                </c:pt>
                <c:pt idx="1">
                  <c:v>1.6873818564396122E-2</c:v>
                </c:pt>
                <c:pt idx="2">
                  <c:v>0.68965987938784945</c:v>
                </c:pt>
                <c:pt idx="3">
                  <c:v>-0.39612903672877925</c:v>
                </c:pt>
                <c:pt idx="4">
                  <c:v>-0.83650126771712086</c:v>
                </c:pt>
                <c:pt idx="5">
                  <c:v>-0.384663850235324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29E-3742-AF1F-9BBEAAE39F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99332624"/>
        <c:axId val="1699389376"/>
      </c:scatterChart>
      <c:valAx>
        <c:axId val="1699332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n-MX"/>
          </a:p>
        </c:txPr>
        <c:crossAx val="1699389376"/>
        <c:crossesAt val="0"/>
        <c:crossBetween val="midCat"/>
      </c:valAx>
      <c:valAx>
        <c:axId val="1699389376"/>
        <c:scaling>
          <c:orientation val="minMax"/>
          <c:max val="3"/>
          <c:min val="-3"/>
        </c:scaling>
        <c:delete val="0"/>
        <c:axPos val="l"/>
        <c:majorGridlines>
          <c:spPr>
            <a:ln w="6350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MX"/>
          </a:p>
        </c:txPr>
        <c:crossAx val="1699332624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en-MX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279396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555937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973304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840279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4769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0892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504808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640950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509645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76599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300176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2EEADD-CD1A-D54B-B370-68C92E2BE7B4}" type="datetimeFigureOut">
              <a:rPr lang="en-MX" smtClean="0"/>
              <a:t>18/03/21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55E706-D68F-D143-B5DC-96B8922C6FC2}" type="slidenum">
              <a:rPr lang="en-MX" smtClean="0"/>
              <a:t>‹#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220528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ABDE245-514C-3F48-A01F-6A0D3BA647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8033942"/>
              </p:ext>
            </p:extLst>
          </p:nvPr>
        </p:nvGraphicFramePr>
        <p:xfrm>
          <a:off x="574040" y="534130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3FDE9A8E-7683-4246-95F5-A6597C5E401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0198558"/>
              </p:ext>
            </p:extLst>
          </p:nvPr>
        </p:nvGraphicFramePr>
        <p:xfrm>
          <a:off x="574040" y="2552716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9CD67B05-1A94-8B4A-AE44-C9387AA3FD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2994835"/>
              </p:ext>
            </p:extLst>
          </p:nvPr>
        </p:nvGraphicFramePr>
        <p:xfrm>
          <a:off x="3685511" y="534130"/>
          <a:ext cx="44676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CBC4AE99-0770-BA4E-9418-AB3DB75DCE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5323376"/>
              </p:ext>
            </p:extLst>
          </p:nvPr>
        </p:nvGraphicFramePr>
        <p:xfrm>
          <a:off x="3683711" y="2552716"/>
          <a:ext cx="44676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C886059F-E079-0847-AE0B-6D75EF95BDBF}"/>
              </a:ext>
            </a:extLst>
          </p:cNvPr>
          <p:cNvSpPr txBox="1"/>
          <p:nvPr/>
        </p:nvSpPr>
        <p:spPr>
          <a:xfrm rot="16200000">
            <a:off x="-996046" y="2378288"/>
            <a:ext cx="29883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MX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(% observed / % in reference probes)</a:t>
            </a:r>
          </a:p>
        </p:txBody>
      </p:sp>
      <p:sp>
        <p:nvSpPr>
          <p:cNvPr id="13" name="CuadroTexto 126">
            <a:extLst>
              <a:ext uri="{FF2B5EF4-FFF2-40B4-BE49-F238E27FC236}">
                <a16:creationId xmlns:a16="http://schemas.microsoft.com/office/drawing/2014/main" id="{0F7A42B3-78D9-FA47-AB77-B5898D1B01C5}"/>
              </a:ext>
            </a:extLst>
          </p:cNvPr>
          <p:cNvSpPr txBox="1"/>
          <p:nvPr/>
        </p:nvSpPr>
        <p:spPr>
          <a:xfrm>
            <a:off x="539958" y="5112620"/>
            <a:ext cx="8301827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/>
                <a:cs typeface="Arial"/>
              </a:rPr>
              <a:t>Supplementary Figure 4. Genomic distribution of dmCpG relative to gene compartments.</a:t>
            </a:r>
            <a:r>
              <a:rPr lang="en-GB" sz="1100" dirty="0">
                <a:latin typeface="Arial"/>
                <a:cs typeface="Arial"/>
              </a:rPr>
              <a:t> Upper graphs, FS. Lower graphs, PS. X axis (zero enrichment) represents the reference probe distribution. TSS, 1.5 kb region upstream of transcription start site. For simplicity, the very low value (log</a:t>
            </a:r>
            <a:r>
              <a:rPr lang="en-GB" sz="1100" baseline="-25000" dirty="0">
                <a:latin typeface="Arial"/>
                <a:cs typeface="Arial"/>
              </a:rPr>
              <a:t>2</a:t>
            </a:r>
            <a:r>
              <a:rPr lang="en-GB" sz="1100" dirty="0">
                <a:latin typeface="Arial"/>
                <a:cs typeface="Arial"/>
              </a:rPr>
              <a:t>(~0)) of selected data points in FS FA-dmCpG are placed at the bottom of the graph and the true value is indicated (arrow). Significance of comparisons between BMI-dmCpG and each FA-dmCpG (horizontal bars between graphs), between each FA-dmCpG in FS and PS (vertical bars on the right-hand side of data series list) and between each FA-dmCpG and reference probe distribution (right-hand side of each data series) are shown. *, p&lt;0.05; **, p&lt;0.01; ***, p&lt;0.001; non-significant comparisons are not indicated (Chi-square test)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A1C64B9-310F-3B45-BD65-7EE748EECFF2}"/>
              </a:ext>
            </a:extLst>
          </p:cNvPr>
          <p:cNvSpPr txBox="1"/>
          <p:nvPr/>
        </p:nvSpPr>
        <p:spPr>
          <a:xfrm rot="18500010">
            <a:off x="984340" y="4345210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742736B-CCE9-194C-8494-0A1F6B3DFF39}"/>
              </a:ext>
            </a:extLst>
          </p:cNvPr>
          <p:cNvSpPr txBox="1"/>
          <p:nvPr/>
        </p:nvSpPr>
        <p:spPr>
          <a:xfrm rot="18500010">
            <a:off x="1424435" y="4464376"/>
            <a:ext cx="7649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1st exon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726670A-410C-9C41-89AC-3C5A2B3512A9}"/>
              </a:ext>
            </a:extLst>
          </p:cNvPr>
          <p:cNvSpPr txBox="1"/>
          <p:nvPr/>
        </p:nvSpPr>
        <p:spPr>
          <a:xfrm rot="18500010">
            <a:off x="1209775" y="4398021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4BD5813-A383-F446-AE43-27A4042E761A}"/>
              </a:ext>
            </a:extLst>
          </p:cNvPr>
          <p:cNvSpPr txBox="1"/>
          <p:nvPr/>
        </p:nvSpPr>
        <p:spPr>
          <a:xfrm rot="18500010">
            <a:off x="2232584" y="4398021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3’UTR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BD8D533-8840-3C4D-8AA0-5BB046EFCBE2}"/>
              </a:ext>
            </a:extLst>
          </p:cNvPr>
          <p:cNvSpPr txBox="1"/>
          <p:nvPr/>
        </p:nvSpPr>
        <p:spPr>
          <a:xfrm rot="18500010">
            <a:off x="1971038" y="4364700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Body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3221EAB-9FDE-1B4C-B9D5-3984135473E4}"/>
              </a:ext>
            </a:extLst>
          </p:cNvPr>
          <p:cNvSpPr txBox="1"/>
          <p:nvPr/>
        </p:nvSpPr>
        <p:spPr>
          <a:xfrm rot="18500010">
            <a:off x="2384714" y="4491699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Intergenic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C54C004-EBD1-B140-A522-7F6C87FB01F2}"/>
              </a:ext>
            </a:extLst>
          </p:cNvPr>
          <p:cNvSpPr txBox="1"/>
          <p:nvPr/>
        </p:nvSpPr>
        <p:spPr>
          <a:xfrm rot="18500010">
            <a:off x="4093165" y="4306780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BFED497-F983-3B47-B2DB-1F83443AAE36}"/>
              </a:ext>
            </a:extLst>
          </p:cNvPr>
          <p:cNvSpPr txBox="1"/>
          <p:nvPr/>
        </p:nvSpPr>
        <p:spPr>
          <a:xfrm rot="18500010">
            <a:off x="4549471" y="4416803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1st exon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DC9CAD5-13F1-BF4A-BE68-4C6AAA93D09E}"/>
              </a:ext>
            </a:extLst>
          </p:cNvPr>
          <p:cNvSpPr txBox="1"/>
          <p:nvPr/>
        </p:nvSpPr>
        <p:spPr>
          <a:xfrm rot="18500010">
            <a:off x="4339382" y="4359591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FB25A74-F096-9244-8CD4-30E4718064B3}"/>
              </a:ext>
            </a:extLst>
          </p:cNvPr>
          <p:cNvSpPr txBox="1"/>
          <p:nvPr/>
        </p:nvSpPr>
        <p:spPr>
          <a:xfrm rot="18500010">
            <a:off x="5344480" y="4359591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3’UTR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F33F409-6C2A-CA42-890E-19F50D296E4E}"/>
              </a:ext>
            </a:extLst>
          </p:cNvPr>
          <p:cNvSpPr txBox="1"/>
          <p:nvPr/>
        </p:nvSpPr>
        <p:spPr>
          <a:xfrm rot="18500010">
            <a:off x="5087814" y="4326270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Body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A25D2FD-CA3A-8E41-A52F-F5E7C686E6C2}"/>
              </a:ext>
            </a:extLst>
          </p:cNvPr>
          <p:cNvSpPr txBox="1"/>
          <p:nvPr/>
        </p:nvSpPr>
        <p:spPr>
          <a:xfrm rot="18500010">
            <a:off x="5496610" y="4453269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Intergeni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5A769C5-6475-EB4E-81FA-DE32C9A91793}"/>
              </a:ext>
            </a:extLst>
          </p:cNvPr>
          <p:cNvSpPr txBox="1"/>
          <p:nvPr/>
        </p:nvSpPr>
        <p:spPr>
          <a:xfrm>
            <a:off x="1600879" y="673176"/>
            <a:ext cx="11865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FS BMI-dmCpG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E7A1433-329F-1942-9BBC-2B62224CD016}"/>
              </a:ext>
            </a:extLst>
          </p:cNvPr>
          <p:cNvSpPr txBox="1"/>
          <p:nvPr/>
        </p:nvSpPr>
        <p:spPr>
          <a:xfrm>
            <a:off x="1592864" y="2691968"/>
            <a:ext cx="1194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PS BMI-dmCpG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E94D6F3-0C7D-C74F-B039-7495BDB7C431}"/>
              </a:ext>
            </a:extLst>
          </p:cNvPr>
          <p:cNvSpPr txBox="1"/>
          <p:nvPr/>
        </p:nvSpPr>
        <p:spPr>
          <a:xfrm>
            <a:off x="4715935" y="670128"/>
            <a:ext cx="11176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FS FA-dmCpG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DA098A2-B512-2247-BA26-10A6A9AAD944}"/>
              </a:ext>
            </a:extLst>
          </p:cNvPr>
          <p:cNvSpPr txBox="1"/>
          <p:nvPr/>
        </p:nvSpPr>
        <p:spPr>
          <a:xfrm>
            <a:off x="4707920" y="2691968"/>
            <a:ext cx="11256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PS FA-dmCpG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D80C9824-6F94-5143-BA06-814E42441863}"/>
              </a:ext>
            </a:extLst>
          </p:cNvPr>
          <p:cNvCxnSpPr/>
          <p:nvPr/>
        </p:nvCxnSpPr>
        <p:spPr>
          <a:xfrm>
            <a:off x="7791699" y="1130376"/>
            <a:ext cx="0" cy="201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45CEA66-EB5F-1B42-AE43-4E583C6480AF}"/>
              </a:ext>
            </a:extLst>
          </p:cNvPr>
          <p:cNvCxnSpPr/>
          <p:nvPr/>
        </p:nvCxnSpPr>
        <p:spPr>
          <a:xfrm>
            <a:off x="7840515" y="1337640"/>
            <a:ext cx="0" cy="201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C3312754-9552-6E4E-B95A-0A6F7E62A0C8}"/>
              </a:ext>
            </a:extLst>
          </p:cNvPr>
          <p:cNvCxnSpPr/>
          <p:nvPr/>
        </p:nvCxnSpPr>
        <p:spPr>
          <a:xfrm>
            <a:off x="7889331" y="1544904"/>
            <a:ext cx="0" cy="201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4655651D-052F-794A-A467-CE8097B33085}"/>
              </a:ext>
            </a:extLst>
          </p:cNvPr>
          <p:cNvCxnSpPr/>
          <p:nvPr/>
        </p:nvCxnSpPr>
        <p:spPr>
          <a:xfrm>
            <a:off x="7931147" y="1770456"/>
            <a:ext cx="0" cy="201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BC1A2938-BDFB-3843-9C28-29E1D7363E7B}"/>
              </a:ext>
            </a:extLst>
          </p:cNvPr>
          <p:cNvSpPr/>
          <p:nvPr/>
        </p:nvSpPr>
        <p:spPr>
          <a:xfrm>
            <a:off x="6485054" y="498814"/>
            <a:ext cx="269940" cy="38329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X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8C5D338F-41FA-C54F-8FB1-B86167552B61}"/>
              </a:ext>
            </a:extLst>
          </p:cNvPr>
          <p:cNvSpPr/>
          <p:nvPr/>
        </p:nvSpPr>
        <p:spPr>
          <a:xfrm>
            <a:off x="3383838" y="538480"/>
            <a:ext cx="350729" cy="38329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X"/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97EF02B6-32B4-DA4F-A5D9-2A06A9245A39}"/>
              </a:ext>
            </a:extLst>
          </p:cNvPr>
          <p:cNvCxnSpPr>
            <a:cxnSpLocks/>
          </p:cNvCxnSpPr>
          <p:nvPr/>
        </p:nvCxnSpPr>
        <p:spPr>
          <a:xfrm>
            <a:off x="2189143" y="573260"/>
            <a:ext cx="30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05F3DDDC-8E06-514F-936B-234F3DA68F06}"/>
              </a:ext>
            </a:extLst>
          </p:cNvPr>
          <p:cNvSpPr txBox="1"/>
          <p:nvPr/>
        </p:nvSpPr>
        <p:spPr>
          <a:xfrm>
            <a:off x="3230067" y="327291"/>
            <a:ext cx="978152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: PA-dmCpG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C139ED01-79DB-3F4B-BADC-06CEF7B3B176}"/>
              </a:ext>
            </a:extLst>
          </p:cNvPr>
          <p:cNvCxnSpPr>
            <a:cxnSpLocks/>
          </p:cNvCxnSpPr>
          <p:nvPr/>
        </p:nvCxnSpPr>
        <p:spPr>
          <a:xfrm>
            <a:off x="2199510" y="2591036"/>
            <a:ext cx="30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5B475D49-4B7B-3141-B20B-385F1AB52000}"/>
              </a:ext>
            </a:extLst>
          </p:cNvPr>
          <p:cNvSpPr txBox="1"/>
          <p:nvPr/>
        </p:nvSpPr>
        <p:spPr>
          <a:xfrm>
            <a:off x="2048099" y="2358743"/>
            <a:ext cx="3337773" cy="2359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: PA-dmCpG, C20:1-dmCpG, EDA-dmCpG, DGLA-dmCpG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81CBC77-1C33-E64D-8189-19C3E22D4422}"/>
              </a:ext>
            </a:extLst>
          </p:cNvPr>
          <p:cNvSpPr txBox="1"/>
          <p:nvPr/>
        </p:nvSpPr>
        <p:spPr>
          <a:xfrm rot="5400000">
            <a:off x="7815826" y="2117978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BF8BD15-E216-864C-8AF3-E66122D625E1}"/>
              </a:ext>
            </a:extLst>
          </p:cNvPr>
          <p:cNvSpPr txBox="1"/>
          <p:nvPr/>
        </p:nvSpPr>
        <p:spPr>
          <a:xfrm rot="5400000">
            <a:off x="7546988" y="2663825"/>
            <a:ext cx="9925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(all FA-dmCpG)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5E3860EA-4E7D-5E44-B03D-639F8FC26AED}"/>
              </a:ext>
            </a:extLst>
          </p:cNvPr>
          <p:cNvCxnSpPr/>
          <p:nvPr/>
        </p:nvCxnSpPr>
        <p:spPr>
          <a:xfrm flipV="1">
            <a:off x="5738947" y="2240022"/>
            <a:ext cx="0" cy="10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9F65F96A-3B39-8C4E-B427-B84519E47D3A}"/>
              </a:ext>
            </a:extLst>
          </p:cNvPr>
          <p:cNvCxnSpPr>
            <a:cxnSpLocks/>
          </p:cNvCxnSpPr>
          <p:nvPr/>
        </p:nvCxnSpPr>
        <p:spPr>
          <a:xfrm rot="2700000">
            <a:off x="5137574" y="2061479"/>
            <a:ext cx="0" cy="10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C13A8F9A-7AA9-C34C-8840-C4B76671E275}"/>
              </a:ext>
            </a:extLst>
          </p:cNvPr>
          <p:cNvSpPr txBox="1"/>
          <p:nvPr/>
        </p:nvSpPr>
        <p:spPr>
          <a:xfrm>
            <a:off x="4957543" y="1897395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-18.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A7C6358-B96B-724A-A191-98CC57ADEC7B}"/>
              </a:ext>
            </a:extLst>
          </p:cNvPr>
          <p:cNvSpPr txBox="1"/>
          <p:nvPr/>
        </p:nvSpPr>
        <p:spPr>
          <a:xfrm>
            <a:off x="5525946" y="2285908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-17.9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A8BC575-66FD-6448-BE61-6E81DFEC7266}"/>
              </a:ext>
            </a:extLst>
          </p:cNvPr>
          <p:cNvSpPr txBox="1"/>
          <p:nvPr/>
        </p:nvSpPr>
        <p:spPr>
          <a:xfrm>
            <a:off x="7313920" y="957139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EB140BE-C7AC-B141-B68E-B8C3F1203DFB}"/>
              </a:ext>
            </a:extLst>
          </p:cNvPr>
          <p:cNvSpPr txBox="1"/>
          <p:nvPr/>
        </p:nvSpPr>
        <p:spPr>
          <a:xfrm>
            <a:off x="7381650" y="1388944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0F966D1-31C7-A941-B305-3FE6A5E87E93}"/>
              </a:ext>
            </a:extLst>
          </p:cNvPr>
          <p:cNvSpPr txBox="1"/>
          <p:nvPr/>
        </p:nvSpPr>
        <p:spPr>
          <a:xfrm>
            <a:off x="7449386" y="1600610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0724A2D-3D59-5F46-B689-6E510B8E0BED}"/>
              </a:ext>
            </a:extLst>
          </p:cNvPr>
          <p:cNvSpPr txBox="1"/>
          <p:nvPr/>
        </p:nvSpPr>
        <p:spPr>
          <a:xfrm>
            <a:off x="7308740" y="2984020"/>
            <a:ext cx="396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229F004-A29C-8C46-8FC6-CEFCA0FBF97E}"/>
              </a:ext>
            </a:extLst>
          </p:cNvPr>
          <p:cNvSpPr txBox="1"/>
          <p:nvPr/>
        </p:nvSpPr>
        <p:spPr>
          <a:xfrm>
            <a:off x="7444206" y="3195689"/>
            <a:ext cx="396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A969E99-C734-514F-81D2-460CFC997616}"/>
              </a:ext>
            </a:extLst>
          </p:cNvPr>
          <p:cNvSpPr txBox="1"/>
          <p:nvPr/>
        </p:nvSpPr>
        <p:spPr>
          <a:xfrm>
            <a:off x="7376469" y="3407358"/>
            <a:ext cx="396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05E6DF3-B66B-564A-ADFE-1B322CE7B27A}"/>
              </a:ext>
            </a:extLst>
          </p:cNvPr>
          <p:cNvSpPr txBox="1"/>
          <p:nvPr/>
        </p:nvSpPr>
        <p:spPr>
          <a:xfrm>
            <a:off x="7444203" y="3627488"/>
            <a:ext cx="396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18702092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639D6C5-A2FC-0446-84E3-514C063D30D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0034716"/>
              </p:ext>
            </p:extLst>
          </p:nvPr>
        </p:nvGraphicFramePr>
        <p:xfrm>
          <a:off x="563289" y="567592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412DB82C-B0FD-3E4A-99B4-FF67014A6D0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8239768"/>
              </p:ext>
            </p:extLst>
          </p:nvPr>
        </p:nvGraphicFramePr>
        <p:xfrm>
          <a:off x="563289" y="2609672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E72789DE-1628-2846-BAC9-7EF56EE22B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6584961"/>
              </p:ext>
            </p:extLst>
          </p:nvPr>
        </p:nvGraphicFramePr>
        <p:xfrm>
          <a:off x="3725502" y="567592"/>
          <a:ext cx="44676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EC3BA685-B069-C84D-89B7-338B4209BB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10536046"/>
              </p:ext>
            </p:extLst>
          </p:nvPr>
        </p:nvGraphicFramePr>
        <p:xfrm>
          <a:off x="3725502" y="2609672"/>
          <a:ext cx="44676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4F5E4AE0-C58B-8C48-8823-E6CCF0D1FC06}"/>
              </a:ext>
            </a:extLst>
          </p:cNvPr>
          <p:cNvSpPr txBox="1"/>
          <p:nvPr/>
        </p:nvSpPr>
        <p:spPr>
          <a:xfrm rot="16200000">
            <a:off x="-1012625" y="2344690"/>
            <a:ext cx="29883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MX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(% observed / % in reference probes)</a:t>
            </a:r>
          </a:p>
        </p:txBody>
      </p:sp>
      <p:sp>
        <p:nvSpPr>
          <p:cNvPr id="28" name="CuadroTexto 126">
            <a:extLst>
              <a:ext uri="{FF2B5EF4-FFF2-40B4-BE49-F238E27FC236}">
                <a16:creationId xmlns:a16="http://schemas.microsoft.com/office/drawing/2014/main" id="{1AC1E1B5-EBB7-9847-A8A2-75EB1D398EB5}"/>
              </a:ext>
            </a:extLst>
          </p:cNvPr>
          <p:cNvSpPr txBox="1"/>
          <p:nvPr/>
        </p:nvSpPr>
        <p:spPr>
          <a:xfrm>
            <a:off x="481534" y="5249143"/>
            <a:ext cx="830182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/>
                <a:cs typeface="Arial"/>
              </a:rPr>
              <a:t>Supplementary Figure 4 (continued). Genomic distribution of dmCpG relative to CpG islands.</a:t>
            </a:r>
            <a:r>
              <a:rPr lang="en-GB" sz="1100" dirty="0">
                <a:latin typeface="Arial"/>
                <a:cs typeface="Arial"/>
              </a:rPr>
              <a:t> X axis (zero enrichment) represents the reference probe distribution. Shore, 2 kb region adjacent to either side of CpG island. Shelf, 2 kb region adjacent to shore, on either side of CpG island. Open sea, DNA not in CpG island, shore or shelf. For simplicity, the very low value (log</a:t>
            </a:r>
            <a:r>
              <a:rPr lang="en-GB" sz="1100" baseline="-25000" dirty="0">
                <a:latin typeface="Arial"/>
                <a:cs typeface="Arial"/>
              </a:rPr>
              <a:t>2</a:t>
            </a:r>
            <a:r>
              <a:rPr lang="en-GB" sz="1100" dirty="0">
                <a:latin typeface="Arial"/>
                <a:cs typeface="Arial"/>
              </a:rPr>
              <a:t>(~0)) of selected data points in FS FA-dmCpG are placed at the bottom of the graph and the true value is indicated (arrow). Significance of comparisons between BMI-dmCpG and each FA-dmCpG (horizontal bars between graphs), between each FA-dmCpG in FS and PS (vertical bars on the right-hand side of data series list) and between each FA-dmCpG and reference probe distribution (right-hand side of each data series) are shown. *, p&lt;0.05; **, p&lt;0.01; ***, p&lt;0.001; non-significant comparisons are not indicated (Chi-square test).</a:t>
            </a:r>
            <a:endParaRPr lang="en-GB" sz="1100" b="1" dirty="0">
              <a:latin typeface="Arial"/>
              <a:cs typeface="Arial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C35692E-A756-2B47-B696-D593CA0627E3}"/>
              </a:ext>
            </a:extLst>
          </p:cNvPr>
          <p:cNvSpPr txBox="1"/>
          <p:nvPr/>
        </p:nvSpPr>
        <p:spPr>
          <a:xfrm rot="18500010">
            <a:off x="3899426" y="4536571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pG islan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9950EDB-7122-0540-A1C8-1519F419D5F4}"/>
              </a:ext>
            </a:extLst>
          </p:cNvPr>
          <p:cNvSpPr txBox="1"/>
          <p:nvPr/>
        </p:nvSpPr>
        <p:spPr>
          <a:xfrm rot="18500010">
            <a:off x="5168755" y="4376251"/>
            <a:ext cx="5341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Shelf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D0620E8-F034-4B49-BEFD-6DF739716107}"/>
              </a:ext>
            </a:extLst>
          </p:cNvPr>
          <p:cNvSpPr txBox="1"/>
          <p:nvPr/>
        </p:nvSpPr>
        <p:spPr>
          <a:xfrm rot="18500010">
            <a:off x="4661038" y="439951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Shor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E94818F-576B-894E-99AB-F928FFB52895}"/>
              </a:ext>
            </a:extLst>
          </p:cNvPr>
          <p:cNvSpPr txBox="1"/>
          <p:nvPr/>
        </p:nvSpPr>
        <p:spPr>
          <a:xfrm rot="18500010">
            <a:off x="5392857" y="4500106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Open se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668D069-8223-6E47-B10C-1F672FBF1641}"/>
              </a:ext>
            </a:extLst>
          </p:cNvPr>
          <p:cNvSpPr txBox="1"/>
          <p:nvPr/>
        </p:nvSpPr>
        <p:spPr>
          <a:xfrm rot="18500010">
            <a:off x="791444" y="4536571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pG islan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0355911-6382-244F-9E89-0F8479E17784}"/>
              </a:ext>
            </a:extLst>
          </p:cNvPr>
          <p:cNvSpPr txBox="1"/>
          <p:nvPr/>
        </p:nvSpPr>
        <p:spPr>
          <a:xfrm rot="18500010">
            <a:off x="2193416" y="4376251"/>
            <a:ext cx="5341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Shelf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A9D9B78-EA24-CA47-BA62-7571837C001C}"/>
              </a:ext>
            </a:extLst>
          </p:cNvPr>
          <p:cNvSpPr txBox="1"/>
          <p:nvPr/>
        </p:nvSpPr>
        <p:spPr>
          <a:xfrm rot="18500010">
            <a:off x="1620913" y="439951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Shor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AA134F2-1B70-A046-8EEE-33C613CEC430}"/>
              </a:ext>
            </a:extLst>
          </p:cNvPr>
          <p:cNvSpPr txBox="1"/>
          <p:nvPr/>
        </p:nvSpPr>
        <p:spPr>
          <a:xfrm rot="18500010">
            <a:off x="2471913" y="4500106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Open se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D477C83-21BC-C541-B8F5-321C652DA3C6}"/>
              </a:ext>
            </a:extLst>
          </p:cNvPr>
          <p:cNvSpPr txBox="1"/>
          <p:nvPr/>
        </p:nvSpPr>
        <p:spPr>
          <a:xfrm>
            <a:off x="1536192" y="710332"/>
            <a:ext cx="11865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FS BMI-dmCpG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8984185-1F57-7745-ADE6-F7938808F8EB}"/>
              </a:ext>
            </a:extLst>
          </p:cNvPr>
          <p:cNvSpPr txBox="1"/>
          <p:nvPr/>
        </p:nvSpPr>
        <p:spPr>
          <a:xfrm>
            <a:off x="1533144" y="2747412"/>
            <a:ext cx="11945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PS BMI-dmCp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FBC2D97-B4BB-244E-A049-84E8EA013E3A}"/>
              </a:ext>
            </a:extLst>
          </p:cNvPr>
          <p:cNvSpPr txBox="1"/>
          <p:nvPr/>
        </p:nvSpPr>
        <p:spPr>
          <a:xfrm>
            <a:off x="4696968" y="707284"/>
            <a:ext cx="11176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FS FA-dmCpG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9F2CC3F-8990-6044-9EBB-7D1C7B606BD8}"/>
              </a:ext>
            </a:extLst>
          </p:cNvPr>
          <p:cNvSpPr txBox="1"/>
          <p:nvPr/>
        </p:nvSpPr>
        <p:spPr>
          <a:xfrm>
            <a:off x="4700016" y="2747412"/>
            <a:ext cx="11256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PS FA-dmCpG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A202B4D0-1C88-2048-BF04-7637313E5154}"/>
              </a:ext>
            </a:extLst>
          </p:cNvPr>
          <p:cNvCxnSpPr>
            <a:cxnSpLocks/>
          </p:cNvCxnSpPr>
          <p:nvPr/>
        </p:nvCxnSpPr>
        <p:spPr>
          <a:xfrm>
            <a:off x="2137523" y="576220"/>
            <a:ext cx="30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BA6D4318-D78F-1C49-89C0-53B3388A1AE9}"/>
              </a:ext>
            </a:extLst>
          </p:cNvPr>
          <p:cNvSpPr txBox="1"/>
          <p:nvPr/>
        </p:nvSpPr>
        <p:spPr>
          <a:xfrm>
            <a:off x="2218248" y="279896"/>
            <a:ext cx="28985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24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MX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: DGLA-dmCpG; </a:t>
            </a:r>
            <a:r>
              <a:rPr lang="en-MX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: C20:1-dmCpG, EDA-dmCpG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F5DBA2D-4263-894D-8F9F-F0401A529789}"/>
              </a:ext>
            </a:extLst>
          </p:cNvPr>
          <p:cNvCxnSpPr/>
          <p:nvPr/>
        </p:nvCxnSpPr>
        <p:spPr>
          <a:xfrm>
            <a:off x="7923088" y="1149244"/>
            <a:ext cx="0" cy="201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2F269BAF-AD53-5F48-83A7-B076FBD9F7C1}"/>
              </a:ext>
            </a:extLst>
          </p:cNvPr>
          <p:cNvCxnSpPr/>
          <p:nvPr/>
        </p:nvCxnSpPr>
        <p:spPr>
          <a:xfrm>
            <a:off x="7973884" y="1356508"/>
            <a:ext cx="0" cy="201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040F4D6B-D99E-B44F-9D3B-809106544C12}"/>
              </a:ext>
            </a:extLst>
          </p:cNvPr>
          <p:cNvCxnSpPr/>
          <p:nvPr/>
        </p:nvCxnSpPr>
        <p:spPr>
          <a:xfrm>
            <a:off x="8024686" y="1563772"/>
            <a:ext cx="0" cy="201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5CAAE224-A823-C041-BE88-361460D4C9F2}"/>
              </a:ext>
            </a:extLst>
          </p:cNvPr>
          <p:cNvCxnSpPr/>
          <p:nvPr/>
        </p:nvCxnSpPr>
        <p:spPr>
          <a:xfrm>
            <a:off x="8075482" y="1789324"/>
            <a:ext cx="0" cy="2016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1482C16-9119-5649-9A9F-5FFEB1D713A3}"/>
              </a:ext>
            </a:extLst>
          </p:cNvPr>
          <p:cNvSpPr txBox="1"/>
          <p:nvPr/>
        </p:nvSpPr>
        <p:spPr>
          <a:xfrm rot="5400000">
            <a:off x="7947203" y="2148376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97673DB6-8C06-CC47-9C3B-0BD490873BD8}"/>
              </a:ext>
            </a:extLst>
          </p:cNvPr>
          <p:cNvSpPr/>
          <p:nvPr/>
        </p:nvSpPr>
        <p:spPr>
          <a:xfrm>
            <a:off x="3296440" y="584780"/>
            <a:ext cx="350729" cy="38329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MX"/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02FA4160-22D0-4E4D-B75A-8E1C9A237EA7}"/>
              </a:ext>
            </a:extLst>
          </p:cNvPr>
          <p:cNvCxnSpPr>
            <a:cxnSpLocks/>
          </p:cNvCxnSpPr>
          <p:nvPr/>
        </p:nvCxnSpPr>
        <p:spPr>
          <a:xfrm>
            <a:off x="2137523" y="2621428"/>
            <a:ext cx="306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D2D49183-13D3-D745-919B-8C37E801D53F}"/>
              </a:ext>
            </a:extLst>
          </p:cNvPr>
          <p:cNvSpPr txBox="1"/>
          <p:nvPr/>
        </p:nvSpPr>
        <p:spPr>
          <a:xfrm>
            <a:off x="2663882" y="2315965"/>
            <a:ext cx="20072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24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MX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: PA-dmCpG; </a:t>
            </a:r>
            <a:r>
              <a:rPr lang="en-MX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: DGLA-dmCpG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4D81ED6-B595-E549-906A-6B2E1D6D528C}"/>
              </a:ext>
            </a:extLst>
          </p:cNvPr>
          <p:cNvSpPr txBox="1"/>
          <p:nvPr/>
        </p:nvSpPr>
        <p:spPr>
          <a:xfrm rot="5400000">
            <a:off x="7686155" y="2685422"/>
            <a:ext cx="9925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(all FA-dmCpG)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BB8508FE-C1EB-C745-BCC1-5C7B5816F1C7}"/>
              </a:ext>
            </a:extLst>
          </p:cNvPr>
          <p:cNvCxnSpPr/>
          <p:nvPr/>
        </p:nvCxnSpPr>
        <p:spPr>
          <a:xfrm flipV="1">
            <a:off x="5493304" y="2273837"/>
            <a:ext cx="0" cy="108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AA303387-1DCA-DE41-8BD2-CD77A5B014B7}"/>
              </a:ext>
            </a:extLst>
          </p:cNvPr>
          <p:cNvSpPr txBox="1"/>
          <p:nvPr/>
        </p:nvSpPr>
        <p:spPr>
          <a:xfrm>
            <a:off x="5267079" y="2327209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900" dirty="0">
                <a:latin typeface="Arial" panose="020B0604020202020204" pitchFamily="34" charset="0"/>
                <a:cs typeface="Arial" panose="020B0604020202020204" pitchFamily="34" charset="0"/>
              </a:rPr>
              <a:t>-19.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BA3C65C-5FDA-754E-863C-12A5D681F911}"/>
              </a:ext>
            </a:extLst>
          </p:cNvPr>
          <p:cNvSpPr txBox="1"/>
          <p:nvPr/>
        </p:nvSpPr>
        <p:spPr>
          <a:xfrm>
            <a:off x="7416932" y="3019866"/>
            <a:ext cx="396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6BAE2E8-6077-6D45-B368-307B95872DA2}"/>
              </a:ext>
            </a:extLst>
          </p:cNvPr>
          <p:cNvSpPr txBox="1"/>
          <p:nvPr/>
        </p:nvSpPr>
        <p:spPr>
          <a:xfrm>
            <a:off x="7482903" y="3453672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26A4F75-7C4A-E942-B505-981E210A0016}"/>
              </a:ext>
            </a:extLst>
          </p:cNvPr>
          <p:cNvSpPr txBox="1"/>
          <p:nvPr/>
        </p:nvSpPr>
        <p:spPr>
          <a:xfrm>
            <a:off x="7546732" y="3664658"/>
            <a:ext cx="396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B0EAC4F-BF39-8341-AEBB-69217602C4EE}"/>
              </a:ext>
            </a:extLst>
          </p:cNvPr>
          <p:cNvSpPr txBox="1"/>
          <p:nvPr/>
        </p:nvSpPr>
        <p:spPr>
          <a:xfrm>
            <a:off x="7544286" y="1196040"/>
            <a:ext cx="3962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85CEDE4-993A-724C-A04E-398FB35D26C2}"/>
              </a:ext>
            </a:extLst>
          </p:cNvPr>
          <p:cNvSpPr txBox="1"/>
          <p:nvPr/>
        </p:nvSpPr>
        <p:spPr>
          <a:xfrm>
            <a:off x="7472235" y="1418210"/>
            <a:ext cx="325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568013A-5828-9542-B35B-0DE27A8F7E0E}"/>
              </a:ext>
            </a:extLst>
          </p:cNvPr>
          <p:cNvSpPr txBox="1"/>
          <p:nvPr/>
        </p:nvSpPr>
        <p:spPr>
          <a:xfrm>
            <a:off x="7528206" y="1620052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4246421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7F2EBAD-BEA3-6042-A4FE-1B878D35EC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9381416"/>
              </p:ext>
            </p:extLst>
          </p:nvPr>
        </p:nvGraphicFramePr>
        <p:xfrm>
          <a:off x="1241883" y="1115786"/>
          <a:ext cx="3171091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F68BCAF-AE22-AC46-89BD-4050B12AF2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7219186"/>
              </p:ext>
            </p:extLst>
          </p:nvPr>
        </p:nvGraphicFramePr>
        <p:xfrm>
          <a:off x="4279848" y="1115786"/>
          <a:ext cx="32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48573D0-6512-524C-89FA-319AFDC15C5F}"/>
              </a:ext>
            </a:extLst>
          </p:cNvPr>
          <p:cNvSpPr txBox="1"/>
          <p:nvPr/>
        </p:nvSpPr>
        <p:spPr>
          <a:xfrm rot="16200000">
            <a:off x="184797" y="1763182"/>
            <a:ext cx="17876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MX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(% observed /</a:t>
            </a:r>
          </a:p>
          <a:p>
            <a:pPr algn="ct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% in reference probes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4C2E766-62D7-3144-A788-DFF37864E74B}"/>
              </a:ext>
            </a:extLst>
          </p:cNvPr>
          <p:cNvSpPr txBox="1"/>
          <p:nvPr/>
        </p:nvSpPr>
        <p:spPr>
          <a:xfrm rot="18500010">
            <a:off x="1637877" y="2849876"/>
            <a:ext cx="484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C8C2B7D-CE74-F248-B39F-19F9B6F5C2B5}"/>
              </a:ext>
            </a:extLst>
          </p:cNvPr>
          <p:cNvSpPr txBox="1"/>
          <p:nvPr/>
        </p:nvSpPr>
        <p:spPr>
          <a:xfrm rot="18500010">
            <a:off x="2073401" y="2959899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1st ex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CFBE640-A603-3F48-B551-0AEF6BBF090F}"/>
              </a:ext>
            </a:extLst>
          </p:cNvPr>
          <p:cNvSpPr txBox="1"/>
          <p:nvPr/>
        </p:nvSpPr>
        <p:spPr>
          <a:xfrm rot="18500010">
            <a:off x="1852921" y="2902687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5’UT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2E055B1-7E1A-8642-8496-5121D08472E0}"/>
              </a:ext>
            </a:extLst>
          </p:cNvPr>
          <p:cNvSpPr txBox="1"/>
          <p:nvPr/>
        </p:nvSpPr>
        <p:spPr>
          <a:xfrm rot="18500010">
            <a:off x="2854948" y="2902687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3’UT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A7A43EF-2412-BE40-BB86-E770A84AC0F8}"/>
              </a:ext>
            </a:extLst>
          </p:cNvPr>
          <p:cNvSpPr txBox="1"/>
          <p:nvPr/>
        </p:nvSpPr>
        <p:spPr>
          <a:xfrm rot="18500010">
            <a:off x="2593402" y="2869366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Bod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96AAAD1-A7DA-3F4D-BF7F-53DECC04619F}"/>
              </a:ext>
            </a:extLst>
          </p:cNvPr>
          <p:cNvSpPr txBox="1"/>
          <p:nvPr/>
        </p:nvSpPr>
        <p:spPr>
          <a:xfrm rot="18500010">
            <a:off x="2996687" y="2996365"/>
            <a:ext cx="8579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Intergeni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1180CFF-58D0-9E46-9BF5-97CC6696FE0C}"/>
              </a:ext>
            </a:extLst>
          </p:cNvPr>
          <p:cNvSpPr txBox="1"/>
          <p:nvPr/>
        </p:nvSpPr>
        <p:spPr>
          <a:xfrm rot="18500010">
            <a:off x="4506776" y="3029686"/>
            <a:ext cx="942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CpG islan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572D5BF-6F7D-1546-95F0-8C5F455FC617}"/>
              </a:ext>
            </a:extLst>
          </p:cNvPr>
          <p:cNvSpPr txBox="1"/>
          <p:nvPr/>
        </p:nvSpPr>
        <p:spPr>
          <a:xfrm rot="18500010">
            <a:off x="5906669" y="2869366"/>
            <a:ext cx="5341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Shel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F2D87DE-ED4D-CD4F-A429-C9033679BF28}"/>
              </a:ext>
            </a:extLst>
          </p:cNvPr>
          <p:cNvSpPr txBox="1"/>
          <p:nvPr/>
        </p:nvSpPr>
        <p:spPr>
          <a:xfrm rot="18500010">
            <a:off x="5323775" y="2892628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Shor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095CD8A-5289-D642-AD59-D37CD76AC802}"/>
              </a:ext>
            </a:extLst>
          </p:cNvPr>
          <p:cNvSpPr txBox="1"/>
          <p:nvPr/>
        </p:nvSpPr>
        <p:spPr>
          <a:xfrm rot="18500010">
            <a:off x="6195557" y="2993221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MX" sz="1200" dirty="0">
                <a:latin typeface="Arial" panose="020B0604020202020204" pitchFamily="34" charset="0"/>
                <a:cs typeface="Arial" panose="020B0604020202020204" pitchFamily="34" charset="0"/>
              </a:rPr>
              <a:t>Open sea</a:t>
            </a:r>
          </a:p>
        </p:txBody>
      </p:sp>
      <p:sp>
        <p:nvSpPr>
          <p:cNvPr id="19" name="CuadroTexto 126">
            <a:extLst>
              <a:ext uri="{FF2B5EF4-FFF2-40B4-BE49-F238E27FC236}">
                <a16:creationId xmlns:a16="http://schemas.microsoft.com/office/drawing/2014/main" id="{09E0D3C9-0E5C-6745-8794-E582DE1FBC13}"/>
              </a:ext>
            </a:extLst>
          </p:cNvPr>
          <p:cNvSpPr txBox="1"/>
          <p:nvPr/>
        </p:nvSpPr>
        <p:spPr>
          <a:xfrm>
            <a:off x="847800" y="3809159"/>
            <a:ext cx="745062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/>
                <a:cs typeface="Arial"/>
              </a:rPr>
              <a:t>Supplementary Figure 4 (continued). Genomic distribution of Ow-dmCpG relative to gene compartments and CpG islands.</a:t>
            </a:r>
            <a:r>
              <a:rPr lang="en-GB" sz="1100" dirty="0">
                <a:latin typeface="Arial"/>
                <a:cs typeface="Arial"/>
              </a:rPr>
              <a:t> X axis (zero enrichment) represents the reference probe distribution. TSS, 1.5 kb region upstream of transcription start site</a:t>
            </a:r>
            <a:r>
              <a:rPr lang="en-GB" sz="1100" b="1" dirty="0">
                <a:latin typeface="Arial"/>
                <a:cs typeface="Arial"/>
              </a:rPr>
              <a:t>.</a:t>
            </a:r>
            <a:r>
              <a:rPr lang="en-GB" sz="1100" dirty="0">
                <a:latin typeface="Arial"/>
                <a:cs typeface="Arial"/>
              </a:rPr>
              <a:t> Shore, 2 kb region adjacent to either side of CpG island. Shelf, 2 kb region adjacent to shore, on either side of CpG island. Open sea, DNA not in CpG island, shore or shelf. Statistical significance refers to comparison with reference probe distribution. ***, p&lt;0.001 (Chi-square test).</a:t>
            </a:r>
            <a:endParaRPr lang="en-GB" sz="1100" b="1" dirty="0">
              <a:latin typeface="Arial"/>
              <a:cs typeface="Arial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03141A4-FC79-4E40-B16C-4466A38F36DE}"/>
              </a:ext>
            </a:extLst>
          </p:cNvPr>
          <p:cNvSpPr txBox="1"/>
          <p:nvPr/>
        </p:nvSpPr>
        <p:spPr>
          <a:xfrm>
            <a:off x="2402515" y="1252728"/>
            <a:ext cx="1130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Ow-dmCpG **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E1AA367-6746-2B44-82B6-3AD2FDB555ED}"/>
              </a:ext>
            </a:extLst>
          </p:cNvPr>
          <p:cNvSpPr txBox="1"/>
          <p:nvPr/>
        </p:nvSpPr>
        <p:spPr>
          <a:xfrm>
            <a:off x="5435275" y="1249680"/>
            <a:ext cx="11304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MX" sz="1100" dirty="0">
                <a:latin typeface="Arial" panose="020B0604020202020204" pitchFamily="34" charset="0"/>
                <a:cs typeface="Arial" panose="020B0604020202020204" pitchFamily="34" charset="0"/>
              </a:rPr>
              <a:t>Ow-dmCpG ***</a:t>
            </a:r>
          </a:p>
        </p:txBody>
      </p:sp>
    </p:spTree>
    <p:extLst>
      <p:ext uri="{BB962C8B-B14F-4D97-AF65-F5344CB8AC3E}">
        <p14:creationId xmlns:p14="http://schemas.microsoft.com/office/powerpoint/2010/main" val="247085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</TotalTime>
  <Words>579</Words>
  <Application>Microsoft Macintosh PowerPoint</Application>
  <PresentationFormat>Letter Paper (8.5x11 in)</PresentationFormat>
  <Paragraphs>7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ina</dc:creator>
  <cp:lastModifiedBy>szaina</cp:lastModifiedBy>
  <cp:revision>91</cp:revision>
  <dcterms:created xsi:type="dcterms:W3CDTF">2021-03-14T21:44:18Z</dcterms:created>
  <dcterms:modified xsi:type="dcterms:W3CDTF">2021-03-18T21:22:27Z</dcterms:modified>
</cp:coreProperties>
</file>